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1625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1912D6-07D7-4D18-9FF5-1EFA7049111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864720"/>
            <a:ext cx="10515600" cy="314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4327560"/>
            <a:ext cx="1051560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9714960"/>
            <a:ext cx="1051560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B4F2C2-40CA-43C2-801A-774D7BAA60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864720"/>
            <a:ext cx="10515600" cy="314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4327560"/>
            <a:ext cx="513144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4327560"/>
            <a:ext cx="513144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9714960"/>
            <a:ext cx="513144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9714960"/>
            <a:ext cx="513144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1D97D5-840F-4D58-8E31-0268FCA39C5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864720"/>
            <a:ext cx="10515600" cy="314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4327560"/>
            <a:ext cx="338580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4327560"/>
            <a:ext cx="338580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4327560"/>
            <a:ext cx="338580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9714960"/>
            <a:ext cx="338580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9714960"/>
            <a:ext cx="338580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9714960"/>
            <a:ext cx="338580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FAF340-EE5F-4500-865D-419870912D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864720"/>
            <a:ext cx="10515600" cy="314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4327560"/>
            <a:ext cx="10515600" cy="10314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338"/>
              </a:spcBef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B8C24C-1772-417F-A7D5-95FCFB1D56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864720"/>
            <a:ext cx="10515600" cy="314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4327560"/>
            <a:ext cx="10515600" cy="1031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8A8273-F9CA-4832-B263-A0EAC43A20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864720"/>
            <a:ext cx="10515600" cy="314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4327560"/>
            <a:ext cx="5131440" cy="1031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4327560"/>
            <a:ext cx="5131440" cy="1031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ADA413-5FC3-4819-8710-6A5A68048D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864720"/>
            <a:ext cx="10515600" cy="314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561751-699E-447F-9E1F-B7BE350E27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864720"/>
            <a:ext cx="10515600" cy="14564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338"/>
              </a:spcBef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F2E8B2-6831-404A-A6C8-A52E15ACAD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864720"/>
            <a:ext cx="10515600" cy="314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4327560"/>
            <a:ext cx="513144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4327560"/>
            <a:ext cx="5131440" cy="1031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9714960"/>
            <a:ext cx="513144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DAA702-096A-49EC-80EE-97D68DA43C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864720"/>
            <a:ext cx="10515600" cy="314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4327560"/>
            <a:ext cx="5131440" cy="1031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4327560"/>
            <a:ext cx="513144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9714960"/>
            <a:ext cx="513144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FA07B1-5E0A-4CFF-97FA-F21382394C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864720"/>
            <a:ext cx="10515600" cy="314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4327560"/>
            <a:ext cx="513144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4327560"/>
            <a:ext cx="513144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9714960"/>
            <a:ext cx="10515600" cy="491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D8EBD6-2BB1-440E-AEFA-BB0E81E058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864720"/>
            <a:ext cx="10515600" cy="314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58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4327560"/>
            <a:ext cx="10515600" cy="1031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3120" indent="-30312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1" marL="9129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2" marL="1522440" indent="-30312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3" marL="2131920" indent="-30312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4" marL="27417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5" marL="27417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6" marL="27417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15066720"/>
            <a:ext cx="2743200" cy="86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600" spc="-1" strike="noStrike">
                <a:solidFill>
                  <a:srgbClr val="898989"/>
                </a:solidFill>
                <a:latin typeface="Calibri"/>
                <a:ea typeface="游ゴシック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600" spc="-1" strike="noStrike">
                <a:solidFill>
                  <a:srgbClr val="898989"/>
                </a:solidFill>
                <a:latin typeface="Calibri"/>
                <a:ea typeface="游ゴシック"/>
              </a:rPr>
              <a:t>&lt;date/time&gt;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15066720"/>
            <a:ext cx="4114800" cy="86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15066720"/>
            <a:ext cx="2743200" cy="86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600" spc="-1" strike="noStrike">
                <a:solidFill>
                  <a:srgbClr val="898989"/>
                </a:solidFill>
                <a:latin typeface="Calibri"/>
                <a:ea typeface="游ゴシック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591F2F8-7568-4DA3-BFB2-DD35EBD246B5}" type="slidenum">
              <a:rPr b="0" lang="ja-JP" sz="1600" spc="-1" strike="noStrike">
                <a:solidFill>
                  <a:srgbClr val="898989"/>
                </a:solidFill>
                <a:latin typeface="Calibri"/>
                <a:ea typeface="游ゴシック"/>
              </a:rPr>
              <a:t>&lt;number&gt;</a:t>
            </a:fld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4"/>
          <p:cNvSpPr/>
          <p:nvPr/>
        </p:nvSpPr>
        <p:spPr>
          <a:xfrm>
            <a:off x="9154800" y="15855840"/>
            <a:ext cx="3024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Osaka−等幅"/>
              </a:rPr>
              <a:t>S</a:t>
            </a:r>
            <a:r>
              <a:rPr b="0" lang="en-GB" sz="2000" spc="-1" strike="noStrike">
                <a:solidFill>
                  <a:srgbClr val="000000"/>
                </a:solidFill>
                <a:latin typeface="Arial"/>
                <a:ea typeface="Osaka−等幅"/>
              </a:rPr>
              <a:t>upplementary movie S1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テキスト ボックス 8"/>
          <p:cNvSpPr/>
          <p:nvPr/>
        </p:nvSpPr>
        <p:spPr>
          <a:xfrm>
            <a:off x="1197000" y="4327560"/>
            <a:ext cx="84596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游明朝"/>
              </a:rPr>
              <a:t>Supplementary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mbria"/>
              </a:rPr>
              <a:t> movie S1. 3D image of nerve fibres invading the epidermis in anterior chest keloid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mbria"/>
              </a:rPr>
              <a:t>Cyan represents cell nuclei visualized using DAPI staining, while pink indicates cells positively stained with the anti-PGP9.5 antibody, a marker for nerve fibres. A grid with squares of 50 µm in side length is visible in the background, providing a scale reference for the movi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テキスト ボックス 12"/>
          <p:cNvSpPr/>
          <p:nvPr/>
        </p:nvSpPr>
        <p:spPr>
          <a:xfrm>
            <a:off x="976320" y="874800"/>
            <a:ext cx="44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游ゴシック"/>
              </a:rPr>
              <a:t>S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テキスト ボックス 14"/>
          <p:cNvSpPr/>
          <p:nvPr/>
        </p:nvSpPr>
        <p:spPr>
          <a:xfrm>
            <a:off x="1080" y="0"/>
            <a:ext cx="808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游ゴシック"/>
              </a:rPr>
              <a:t>Three-dimensional Analysis of Intraepidermal Nerve Fibres and Langerhans Cells in Keloids with a Focus on Pruritu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Supplementary movie S1(4;3)" descr=""/>
          <p:cNvPicPr/>
          <p:nvPr/>
        </p:nvPicPr>
        <p:blipFill>
          <a:blip r:embed="rId1"/>
          <a:stretch/>
        </p:blipFill>
        <p:spPr>
          <a:xfrm>
            <a:off x="1766880" y="1247760"/>
            <a:ext cx="4038480" cy="3027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02-14T07:29:39Z</dcterms:created>
  <dc:creator>Haruka Matsuzoe</dc:creator>
  <dc:description/>
  <dc:language>en-US</dc:language>
  <cp:lastModifiedBy>Haruka Matsuzoe</cp:lastModifiedBy>
  <dcterms:modified xsi:type="dcterms:W3CDTF">2025-05-27T08:57:23Z</dcterms:modified>
  <cp:revision>38</cp:revision>
  <dc:subject/>
  <dc:title>PowerPoint Presentation</dc:title>
</cp:coreProperties>
</file>